
<file path=[Content_Types].xml><?xml version="1.0" encoding="utf-8"?>
<Types xmlns="http://schemas.openxmlformats.org/package/2006/content-types"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2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517" r:id="rId3"/>
  </p:sldIdLst>
  <p:sldSz cx="9144000" cy="6858000" type="screen4x3"/>
  <p:notesSz cx="6797675" cy="9926320"/>
  <p:custDataLst>
    <p:tags r:id="rId9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9" userDrawn="1">
          <p15:clr>
            <a:srgbClr val="A4A3A4"/>
          </p15:clr>
        </p15:guide>
        <p15:guide id="2" pos="29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CBE9"/>
    <a:srgbClr val="E5C5F3"/>
    <a:srgbClr val="D1EBFD"/>
    <a:srgbClr val="93CDFE"/>
    <a:srgbClr val="4764A5"/>
    <a:srgbClr val="95CDFF"/>
    <a:srgbClr val="C9A6E4"/>
    <a:srgbClr val="FFFFFF"/>
    <a:srgbClr val="E69190"/>
    <a:srgbClr val="DFED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1" autoAdjust="0"/>
  </p:normalViewPr>
  <p:slideViewPr>
    <p:cSldViewPr snapToGrid="0" showGuides="1">
      <p:cViewPr varScale="1">
        <p:scale>
          <a:sx n="115" d="100"/>
          <a:sy n="115" d="100"/>
        </p:scale>
        <p:origin x="1476" y="114"/>
      </p:cViewPr>
      <p:guideLst>
        <p:guide orient="horz" pos="2149"/>
        <p:guide pos="296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336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5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709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r">
              <a:defRPr sz="1200"/>
            </a:lvl1pPr>
          </a:lstStyle>
          <a:p>
            <a:fld id="{8C46219E-D83A-41C0-9DC5-0B2808AE6EAA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709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r">
              <a:defRPr sz="1200"/>
            </a:lvl1pPr>
          </a:lstStyle>
          <a:p>
            <a:fld id="{7CEFD639-A456-4D1D-ADC3-7F8A141BA253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r">
              <a:defRPr sz="1300"/>
            </a:lvl1pPr>
          </a:lstStyle>
          <a:p>
            <a:fld id="{41995B93-3BDA-4DC1-A0AD-B868635495F7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4695" y="1238250"/>
            <a:ext cx="4468284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9" tIns="47780" rIns="95559" bIns="4778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8"/>
            <a:ext cx="5438140" cy="3908614"/>
          </a:xfrm>
          <a:prstGeom prst="rect">
            <a:avLst/>
          </a:prstGeom>
        </p:spPr>
        <p:txBody>
          <a:bodyPr vert="horz" lIns="95559" tIns="47780" rIns="95559" bIns="47780" rtlCol="0"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r">
              <a:defRPr sz="1300"/>
            </a:lvl1pPr>
          </a:lstStyle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38" y="1122608"/>
            <a:ext cx="7772835" cy="2388121"/>
          </a:xfrm>
        </p:spPr>
        <p:txBody>
          <a:bodyPr anchor="b"/>
          <a:lstStyle>
            <a:lvl1pPr algn="ctr">
              <a:defRPr sz="60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143064" y="3602825"/>
            <a:ext cx="6858384" cy="165612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835" indent="0" algn="ctr">
              <a:buNone/>
              <a:defRPr sz="2005"/>
            </a:lvl2pPr>
            <a:lvl3pPr marL="914400" indent="0" algn="ctr">
              <a:buNone/>
              <a:defRPr sz="1800"/>
            </a:lvl3pPr>
            <a:lvl4pPr marL="1372235" indent="0" algn="ctr">
              <a:buNone/>
              <a:defRPr sz="1600"/>
            </a:lvl4pPr>
            <a:lvl5pPr marL="1829435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2565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8235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EBE44-C8A1-46D5-94B7-0A19D9CB8F77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4C01F-E4DF-4F93-AE9D-CE4EFFCDE5E6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6544041" y="365205"/>
            <a:ext cx="1971785" cy="581310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86" y="365205"/>
            <a:ext cx="5801050" cy="581310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D369-078A-4FF0-AF23-9B57C0DC74A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97D27-0F6C-4588-87CD-B17B11862D5E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3922" y="1710113"/>
            <a:ext cx="7887141" cy="2853360"/>
          </a:xfrm>
        </p:spPr>
        <p:txBody>
          <a:bodyPr anchor="b"/>
          <a:lstStyle>
            <a:lvl1pPr>
              <a:defRPr sz="60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3922" y="4590466"/>
            <a:ext cx="7887141" cy="150051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835" indent="0">
              <a:buNone/>
              <a:defRPr sz="2005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22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4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5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2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8714-C533-4D25-A425-575EB2553755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86" y="1826024"/>
            <a:ext cx="3886417" cy="43522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410" y="1826024"/>
            <a:ext cx="3886417" cy="43522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AF2E-588F-4574-8640-451F19F6797B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77" y="365206"/>
            <a:ext cx="7887141" cy="132585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79" y="1681530"/>
            <a:ext cx="3868556" cy="82409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835" indent="0">
              <a:buNone/>
              <a:defRPr sz="2005" b="1"/>
            </a:lvl2pPr>
            <a:lvl3pPr marL="914400" indent="0">
              <a:buNone/>
              <a:defRPr sz="1800" b="1"/>
            </a:lvl3pPr>
            <a:lvl4pPr marL="1372235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2565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823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79" y="2505622"/>
            <a:ext cx="3868556" cy="368539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410" y="1681530"/>
            <a:ext cx="3887608" cy="82409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835" indent="0">
              <a:buNone/>
              <a:defRPr sz="2005" b="1"/>
            </a:lvl2pPr>
            <a:lvl3pPr marL="914400" indent="0">
              <a:buNone/>
              <a:defRPr sz="1800" b="1"/>
            </a:lvl3pPr>
            <a:lvl4pPr marL="1372235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2565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823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410" y="2505622"/>
            <a:ext cx="3887608" cy="368539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740E9-E684-4879-AC1A-027D0F57D12C}" type="datetime1">
              <a:rPr lang="ko-KR" altLang="en-US" smtClean="0"/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F6F07-08D8-4352-80A8-D6CA92EAF940}" type="datetime1">
              <a:rPr lang="ko-KR" altLang="en-US" smtClean="0"/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D9ABB-2B96-441D-8A23-EA02D08D861A}" type="datetime1">
              <a:rPr lang="ko-KR" altLang="en-US" smtClean="0"/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en-US" smtClean="0"/>
            </a:fld>
            <a:endParaRPr lang="en-US" dirty="0"/>
          </a:p>
        </p:txBody>
      </p:sp>
      <p:sp>
        <p:nvSpPr>
          <p:cNvPr id="5" name="TextBox 4"/>
          <p:cNvSpPr txBox="1"/>
          <p:nvPr userDrawn="1"/>
        </p:nvSpPr>
        <p:spPr>
          <a:xfrm>
            <a:off x="8636541" y="403356"/>
            <a:ext cx="507971" cy="277059"/>
          </a:xfrm>
          <a:prstGeom prst="rect">
            <a:avLst/>
          </a:prstGeom>
        </p:spPr>
        <p:txBody>
          <a:bodyPr vert="horz" lIns="118650" tIns="59324" rIns="118650" bIns="59324" rtlCol="0" anchor="ctr"/>
          <a:lstStyle>
            <a:defPPr>
              <a:defRPr lang="ko-KR"/>
            </a:defPPr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l"/>
            <a:r>
              <a:rPr lang="en-US" sz="1700" dirty="0"/>
              <a:t>/39</a:t>
            </a:r>
            <a:endParaRPr lang="en-US" sz="170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77" y="457300"/>
            <a:ext cx="2949343" cy="1600550"/>
          </a:xfrm>
        </p:spPr>
        <p:txBody>
          <a:bodyPr anchor="b"/>
          <a:lstStyle>
            <a:lvl1pPr>
              <a:defRPr sz="32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3887608" y="987641"/>
            <a:ext cx="4629410" cy="4874690"/>
          </a:xfrm>
        </p:spPr>
        <p:txBody>
          <a:bodyPr/>
          <a:lstStyle>
            <a:lvl1pPr>
              <a:defRPr sz="3205"/>
            </a:lvl1pPr>
            <a:lvl2pPr>
              <a:defRPr sz="2800"/>
            </a:lvl2pPr>
            <a:lvl3pPr>
              <a:defRPr sz="2400"/>
            </a:lvl3pPr>
            <a:lvl4pPr>
              <a:defRPr sz="2005"/>
            </a:lvl4pPr>
            <a:lvl5pPr>
              <a:defRPr sz="2005"/>
            </a:lvl5pPr>
            <a:lvl6pPr>
              <a:defRPr sz="2005"/>
            </a:lvl6pPr>
            <a:lvl7pPr>
              <a:defRPr sz="2005"/>
            </a:lvl7pPr>
            <a:lvl8pPr>
              <a:defRPr sz="2005"/>
            </a:lvl8pPr>
            <a:lvl9pPr>
              <a:defRPr sz="2005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77" y="2057849"/>
            <a:ext cx="2949343" cy="3812420"/>
          </a:xfrm>
        </p:spPr>
        <p:txBody>
          <a:bodyPr/>
          <a:lstStyle>
            <a:lvl1pPr marL="0" indent="0">
              <a:buNone/>
              <a:defRPr sz="1600"/>
            </a:lvl1pPr>
            <a:lvl2pPr marL="457835" indent="0">
              <a:buNone/>
              <a:defRPr sz="1405"/>
            </a:lvl2pPr>
            <a:lvl3pPr marL="914400" indent="0">
              <a:buNone/>
              <a:defRPr sz="1200"/>
            </a:lvl3pPr>
            <a:lvl4pPr marL="1372235" indent="0">
              <a:buNone/>
              <a:defRPr sz="1000"/>
            </a:lvl4pPr>
            <a:lvl5pPr marL="1829435" indent="0">
              <a:buNone/>
              <a:defRPr sz="1000"/>
            </a:lvl5pPr>
            <a:lvl6pPr marL="2286000" indent="0">
              <a:buNone/>
              <a:defRPr sz="1000"/>
            </a:lvl6pPr>
            <a:lvl7pPr marL="2742565" indent="0">
              <a:buNone/>
              <a:defRPr sz="1000"/>
            </a:lvl7pPr>
            <a:lvl8pPr marL="3200400" indent="0">
              <a:buNone/>
              <a:defRPr sz="1000"/>
            </a:lvl8pPr>
            <a:lvl9pPr marL="3658235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5CE22-16BC-42DE-BDF0-C7E49D6F164E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77" y="457300"/>
            <a:ext cx="2949343" cy="1600550"/>
          </a:xfrm>
        </p:spPr>
        <p:txBody>
          <a:bodyPr anchor="b"/>
          <a:lstStyle>
            <a:lvl1pPr>
              <a:defRPr sz="32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3887608" y="987641"/>
            <a:ext cx="4629410" cy="4874690"/>
          </a:xfrm>
        </p:spPr>
        <p:txBody>
          <a:bodyPr anchor="t"/>
          <a:lstStyle>
            <a:lvl1pPr marL="0" indent="0">
              <a:buNone/>
              <a:defRPr sz="3205"/>
            </a:lvl1pPr>
            <a:lvl2pPr marL="457835" indent="0">
              <a:buNone/>
              <a:defRPr sz="2800"/>
            </a:lvl2pPr>
            <a:lvl3pPr marL="914400" indent="0">
              <a:buNone/>
              <a:defRPr sz="2400"/>
            </a:lvl3pPr>
            <a:lvl4pPr marL="1372235" indent="0">
              <a:buNone/>
              <a:defRPr sz="2005"/>
            </a:lvl4pPr>
            <a:lvl5pPr marL="1829435" indent="0">
              <a:buNone/>
              <a:defRPr sz="2005"/>
            </a:lvl5pPr>
            <a:lvl6pPr marL="2286000" indent="0">
              <a:buNone/>
              <a:defRPr sz="2005"/>
            </a:lvl6pPr>
            <a:lvl7pPr marL="2742565" indent="0">
              <a:buNone/>
              <a:defRPr sz="2005"/>
            </a:lvl7pPr>
            <a:lvl8pPr marL="3200400" indent="0">
              <a:buNone/>
              <a:defRPr sz="2005"/>
            </a:lvl8pPr>
            <a:lvl9pPr marL="3658235" indent="0">
              <a:buNone/>
              <a:defRPr sz="200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77" y="2057849"/>
            <a:ext cx="2949343" cy="3812420"/>
          </a:xfrm>
        </p:spPr>
        <p:txBody>
          <a:bodyPr/>
          <a:lstStyle>
            <a:lvl1pPr marL="0" indent="0">
              <a:buNone/>
              <a:defRPr sz="1600"/>
            </a:lvl1pPr>
            <a:lvl2pPr marL="457835" indent="0">
              <a:buNone/>
              <a:defRPr sz="1405"/>
            </a:lvl2pPr>
            <a:lvl3pPr marL="914400" indent="0">
              <a:buNone/>
              <a:defRPr sz="1200"/>
            </a:lvl3pPr>
            <a:lvl4pPr marL="1372235" indent="0">
              <a:buNone/>
              <a:defRPr sz="1000"/>
            </a:lvl4pPr>
            <a:lvl5pPr marL="1829435" indent="0">
              <a:buNone/>
              <a:defRPr sz="1000"/>
            </a:lvl5pPr>
            <a:lvl6pPr marL="2286000" indent="0">
              <a:buNone/>
              <a:defRPr sz="1000"/>
            </a:lvl6pPr>
            <a:lvl7pPr marL="2742565" indent="0">
              <a:buNone/>
              <a:defRPr sz="1000"/>
            </a:lvl7pPr>
            <a:lvl8pPr marL="3200400" indent="0">
              <a:buNone/>
              <a:defRPr sz="1000"/>
            </a:lvl8pPr>
            <a:lvl9pPr marL="3658235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66AD0-4F21-44E9-A6D4-BFF0E3F2D54F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86" y="365206"/>
            <a:ext cx="7887141" cy="1325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86" y="1826024"/>
            <a:ext cx="7887141" cy="4352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86" y="6357739"/>
            <a:ext cx="2057515" cy="365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A7FE-D276-4461-821C-5A41A6583C2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9120" y="6357739"/>
            <a:ext cx="3086273" cy="365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8312" y="6357739"/>
            <a:ext cx="2057515" cy="365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6435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5" kern="1200">
          <a:solidFill>
            <a:schemeClr val="tx1"/>
          </a:solidFill>
          <a:latin typeface="+mn-lt"/>
          <a:ea typeface="+mn-ea"/>
          <a:cs typeface="+mn-cs"/>
        </a:defRPr>
      </a:lvl3pPr>
      <a:lvl4pPr marL="1600835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435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835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835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2235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435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65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8235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tags" Target="../tags/tag4.xml"/><Relationship Id="rId4" Type="http://schemas.openxmlformats.org/officeDocument/2006/relationships/image" Target="../media/image1.tiff"/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" name="文本框 7"/>
          <p:cNvSpPr txBox="1"/>
          <p:nvPr/>
        </p:nvSpPr>
        <p:spPr>
          <a:xfrm>
            <a:off x="0" y="6328410"/>
            <a:ext cx="9144000" cy="460375"/>
          </a:xfrm>
          <a:prstGeom prst="rect">
            <a:avLst/>
          </a:prstGeom>
        </p:spPr>
        <p:txBody>
          <a:bodyPr wrap="square">
            <a:spAutoFit/>
          </a:bodyPr>
          <a:p>
            <a:pPr indent="0" defTabSz="266700" fontAlgn="auto" latinLnBrk="0">
              <a:lnSpc>
                <a:spcPct val="1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latin typeface="Times New Roman" panose="02020603050405020304" pitchFamily="18" charset="0"/>
                <a:ea typeface="Times New Roman" panose="02020603050405020304"/>
                <a:cs typeface="Times New Roman" panose="02020603050405020304" pitchFamily="18" charset="0"/>
              </a:rPr>
              <a:t>Supplementary Figure 3</a:t>
            </a:r>
            <a:r>
              <a:rPr lang="en-US" altLang="zh-CN" sz="1200">
                <a:latin typeface="Times New Roman" panose="02020603050405020304" pitchFamily="18" charset="0"/>
                <a:ea typeface="Times New Roman" panose="02020603050405020304"/>
                <a:cs typeface="Times New Roman" panose="02020603050405020304" pitchFamily="18" charset="0"/>
              </a:rPr>
              <a:t>. Functional Characterization of DEGs Identified by DESeq2. (A) Number of DEGs, (B) Volcano plot of DEGs, the green dots represented down-regulated genes and the red dots represented up-regulated genes.</a:t>
            </a:r>
            <a:endParaRPr lang="en-US" altLang="zh-CN" sz="1200">
              <a:latin typeface="Times New Roman" panose="02020603050405020304" pitchFamily="18" charset="0"/>
              <a:ea typeface="Times New Roman" panose="02020603050405020304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1"/>
            </p:custDataLst>
          </p:nvPr>
        </p:nvSpPr>
        <p:spPr>
          <a:xfrm>
            <a:off x="4711546" y="1434674"/>
            <a:ext cx="614646" cy="30162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365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</a:t>
            </a:r>
            <a:endParaRPr lang="en-US" altLang="zh-CN" sz="1365" b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538079" y="1434674"/>
            <a:ext cx="614646" cy="30162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365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</a:t>
            </a:r>
            <a:endParaRPr lang="en-US" altLang="zh-CN" sz="1365" b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 descr="Figure 9A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2546" t="2440" r="1748" b="1440"/>
          <a:stretch>
            <a:fillRect/>
          </a:stretch>
        </p:blipFill>
        <p:spPr>
          <a:xfrm>
            <a:off x="896834" y="1581207"/>
            <a:ext cx="3406020" cy="3569771"/>
          </a:xfrm>
          <a:prstGeom prst="rect">
            <a:avLst/>
          </a:prstGeom>
        </p:spPr>
      </p:pic>
      <p:pic>
        <p:nvPicPr>
          <p:cNvPr id="3" name="图片 2" descr="Figure 9B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l="1645" t="2440" r="1645" b="1440"/>
          <a:stretch>
            <a:fillRect/>
          </a:stretch>
        </p:blipFill>
        <p:spPr>
          <a:xfrm>
            <a:off x="5039734" y="1581207"/>
            <a:ext cx="3529379" cy="3569771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433.50023622047246,&quot;left&quot;:15.068425196850388,&quot;top&quot;:83.56645669291338,&quot;width&quot;:659.6648818897639}"/>
</p:tagLst>
</file>

<file path=ppt/tags/tag2.xml><?xml version="1.0" encoding="utf-8"?>
<p:tagLst xmlns:p="http://schemas.openxmlformats.org/presentationml/2006/main">
  <p:tag name="KSO_WM_DIAGRAM_VIRTUALLY_FRAME" val="{&quot;height&quot;:433.50023622047246,&quot;left&quot;:15.068425196850388,&quot;top&quot;:83.56645669291338,&quot;width&quot;:659.6648818897639}"/>
</p:tagLst>
</file>

<file path=ppt/tags/tag3.xml><?xml version="1.0" encoding="utf-8"?>
<p:tagLst xmlns:p="http://schemas.openxmlformats.org/presentationml/2006/main">
  <p:tag name="KSO_WM_DIAGRAM_VIRTUALLY_FRAME" val="{&quot;height&quot;:433.50023622047246,&quot;left&quot;:15.068425196850388,&quot;top&quot;:83.56645669291338,&quot;width&quot;:659.6648818897639}"/>
</p:tagLst>
</file>

<file path=ppt/tags/tag4.xml><?xml version="1.0" encoding="utf-8"?>
<p:tagLst xmlns:p="http://schemas.openxmlformats.org/presentationml/2006/main">
  <p:tag name="KSO_WM_DIAGRAM_VIRTUALLY_FRAME" val="{&quot;height&quot;:433.50023622047246,&quot;left&quot;:15.068425196850388,&quot;top&quot;:83.56645669291338,&quot;width&quot;:659.6648818897639}"/>
</p:tagLst>
</file>

<file path=ppt/tags/tag5.xml><?xml version="1.0" encoding="utf-8"?>
<p:tagLst xmlns:p="http://schemas.openxmlformats.org/presentationml/2006/main">
  <p:tag name="KSO_WPP_MARK_KEY" val="cbb28d3e-cd92-42c5-a40b-1275b12b3187"/>
  <p:tag name="COMMONDATA" val="eyJoZGlkIjoiZGFiYjlkYzc4N2RkMzFhNmZmMzMzZjQyN2U1ZTZhYWUifQ=="/>
</p:tagLst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0</Words>
  <Application>WPS 演示</Application>
  <PresentationFormat>화면 슬라이드 쇼(4:3)</PresentationFormat>
  <Paragraphs>6</Paragraphs>
  <Slides>1</Slides>
  <Notes>4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Malgun Gothic</vt:lpstr>
      <vt:lpstr>Calibri Light</vt:lpstr>
      <vt:lpstr>Calibri</vt:lpstr>
      <vt:lpstr>等线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PRESENT</cp:lastModifiedBy>
  <cp:revision>817</cp:revision>
  <cp:lastPrinted>2023-05-18T02:12:00Z</cp:lastPrinted>
  <dcterms:created xsi:type="dcterms:W3CDTF">2018-01-24T06:41:00Z</dcterms:created>
  <dcterms:modified xsi:type="dcterms:W3CDTF">2025-08-21T09:15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C01694E1EFE4BB988246F32DA9EBD06_12</vt:lpwstr>
  </property>
  <property fmtid="{D5CDD505-2E9C-101B-9397-08002B2CF9AE}" pid="3" name="KSOProductBuildVer">
    <vt:lpwstr>2052-12.1.0.22175</vt:lpwstr>
  </property>
</Properties>
</file>